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3959225" cy="5040313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949A43-3B5C-4599-A51A-133383F75FD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98360" y="201240"/>
            <a:ext cx="3564000" cy="83988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98360" y="1176480"/>
            <a:ext cx="3564000" cy="158616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98360" y="2913840"/>
            <a:ext cx="3564000" cy="158616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7EB02D-3958-447D-B3CC-0A0F9C800D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98360" y="201240"/>
            <a:ext cx="3564000" cy="83988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98360" y="1176480"/>
            <a:ext cx="1739160" cy="158616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025000" y="1176480"/>
            <a:ext cx="1739160" cy="158616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98360" y="2913840"/>
            <a:ext cx="1739160" cy="158616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025000" y="2913840"/>
            <a:ext cx="1739160" cy="158616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2A4360-D7C9-42F1-9B98-D8B483EC4CC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98360" y="201240"/>
            <a:ext cx="3564000" cy="83988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98360" y="1176480"/>
            <a:ext cx="1147320" cy="158616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403280" y="1176480"/>
            <a:ext cx="1147320" cy="158616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608560" y="1176480"/>
            <a:ext cx="1147320" cy="158616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98360" y="2913840"/>
            <a:ext cx="1147320" cy="158616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403280" y="2913840"/>
            <a:ext cx="1147320" cy="158616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608560" y="2913840"/>
            <a:ext cx="1147320" cy="158616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EBE598-9B7E-4F7E-BC21-7299F0C3313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98360" y="201240"/>
            <a:ext cx="3564000" cy="83988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98360" y="1176480"/>
            <a:ext cx="3564000" cy="33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7B95BE-B49B-4B14-A378-1128BAB40E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98360" y="201240"/>
            <a:ext cx="3564000" cy="83988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98360" y="1176480"/>
            <a:ext cx="3564000" cy="332568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195110-AA25-4D40-B69F-CBEAA286F7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98360" y="201240"/>
            <a:ext cx="3564000" cy="83988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98360" y="1176480"/>
            <a:ext cx="1739160" cy="332568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025000" y="1176480"/>
            <a:ext cx="1739160" cy="332568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C6F3DB-5166-4FFD-AEF1-130A03F239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98360" y="201240"/>
            <a:ext cx="3564000" cy="83988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09AC58-0AA1-4F45-A78D-1FA687C208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98360" y="201240"/>
            <a:ext cx="3564000" cy="389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83D68C-ADC0-4F26-B671-6356420F04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98360" y="201240"/>
            <a:ext cx="3564000" cy="83988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98360" y="1176480"/>
            <a:ext cx="1739160" cy="158616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025000" y="1176480"/>
            <a:ext cx="1739160" cy="332568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98360" y="2913840"/>
            <a:ext cx="1739160" cy="158616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D54053-22E1-4900-85C9-0A7CA89E5F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98360" y="201240"/>
            <a:ext cx="3564000" cy="83988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98360" y="1176480"/>
            <a:ext cx="1739160" cy="332568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025000" y="1176480"/>
            <a:ext cx="1739160" cy="158616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025000" y="2913840"/>
            <a:ext cx="1739160" cy="158616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56C583-D03B-4EA7-805A-D613FD4249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98360" y="201240"/>
            <a:ext cx="3564000" cy="83988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98360" y="1176480"/>
            <a:ext cx="1739160" cy="158616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025000" y="1176480"/>
            <a:ext cx="1739160" cy="158616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98360" y="2913840"/>
            <a:ext cx="3564000" cy="158616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C90228-E2DB-409A-9E5A-292B3E6B41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98360" y="201240"/>
            <a:ext cx="3564000" cy="83988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98360" y="1176480"/>
            <a:ext cx="3564000" cy="332568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rmAutofit/>
          </a:bodyPr>
          <a:p>
            <a:pPr marL="192240" indent="-19224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417600" indent="-16056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2" marL="642960" indent="-12852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3" marL="900000" indent="-12852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4" marL="1157400" indent="-12852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5" marL="1157400" indent="-12852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6" marL="1157400" indent="-12852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98000" y="4589640"/>
            <a:ext cx="924120" cy="35064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352520" y="4589640"/>
            <a:ext cx="1255680" cy="35064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838600" y="4589640"/>
            <a:ext cx="923760" cy="350640"/>
          </a:xfrm>
          <a:prstGeom prst="rect">
            <a:avLst/>
          </a:prstGeom>
          <a:noFill/>
          <a:ln w="0">
            <a:noFill/>
          </a:ln>
        </p:spPr>
        <p:txBody>
          <a:bodyPr lIns="51480" rIns="51480" tIns="25560" bIns="2556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469D9A6-7678-4221-85A3-3B0E685634D0}" type="slidenum">
              <a:rPr b="0" lang="en-US" sz="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8" descr="zbg22"/>
          <p:cNvPicPr/>
          <p:nvPr/>
        </p:nvPicPr>
        <p:blipFill>
          <a:blip r:embed="rId1"/>
          <a:stretch/>
        </p:blipFill>
        <p:spPr>
          <a:xfrm>
            <a:off x="890640" y="123840"/>
            <a:ext cx="2638440" cy="4754520"/>
          </a:xfrm>
          <a:prstGeom prst="rect">
            <a:avLst/>
          </a:prstGeom>
          <a:ln w="0">
            <a:noFill/>
          </a:ln>
        </p:spPr>
      </p:pic>
      <p:sp>
        <p:nvSpPr>
          <p:cNvPr id="42" name="Text Box 5"/>
          <p:cNvSpPr/>
          <p:nvPr/>
        </p:nvSpPr>
        <p:spPr>
          <a:xfrm>
            <a:off x="2552040" y="28440"/>
            <a:ext cx="1445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C-terminal carboxyl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6"/>
          <p:cNvSpPr/>
          <p:nvPr/>
        </p:nvSpPr>
        <p:spPr>
          <a:xfrm>
            <a:off x="486720" y="773280"/>
            <a:ext cx="1073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central carbony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7"/>
          <p:cNvSpPr/>
          <p:nvPr/>
        </p:nvSpPr>
        <p:spPr>
          <a:xfrm>
            <a:off x="390600" y="1565280"/>
            <a:ext cx="151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ZBG </a:t>
            </a:r>
            <a:r>
              <a:rPr b="0" lang="en-GB" sz="1000" spc="-1" strike="noStrike" u="sng">
                <a:solidFill>
                  <a:srgbClr val="000000"/>
                </a:solidFill>
                <a:uFillTx/>
                <a:latin typeface="Arial"/>
              </a:rPr>
              <a:t>Zinc binding grou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8"/>
          <p:cNvSpPr/>
          <p:nvPr/>
        </p:nvSpPr>
        <p:spPr>
          <a:xfrm>
            <a:off x="2771280" y="1536840"/>
            <a:ext cx="69120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 u="sng">
                <a:solidFill>
                  <a:srgbClr val="000000"/>
                </a:solidFill>
                <a:uFillTx/>
                <a:latin typeface="Arial"/>
              </a:rPr>
              <a:t>P</a:t>
            </a:r>
            <a:r>
              <a:rPr b="0" lang="en-GB" sz="1000" spc="-1" strike="noStrike" u="sng" baseline="-25000">
                <a:solidFill>
                  <a:srgbClr val="000000"/>
                </a:solidFill>
                <a:uFillTx/>
                <a:latin typeface="Arial"/>
              </a:rPr>
              <a:t>1</a:t>
            </a:r>
            <a:r>
              <a:rPr b="0" lang="en-GB" sz="1000" spc="-1" strike="noStrike" u="sng">
                <a:solidFill>
                  <a:srgbClr val="000000"/>
                </a:solidFill>
                <a:uFillTx/>
                <a:latin typeface="Arial"/>
              </a:rPr>
              <a:t>’ grou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9"/>
          <p:cNvSpPr/>
          <p:nvPr/>
        </p:nvSpPr>
        <p:spPr>
          <a:xfrm>
            <a:off x="196920" y="1925640"/>
            <a:ext cx="715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sulfhydry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0"/>
          <p:cNvSpPr/>
          <p:nvPr/>
        </p:nvSpPr>
        <p:spPr>
          <a:xfrm>
            <a:off x="123120" y="2905200"/>
            <a:ext cx="82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carboxyl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1"/>
          <p:cNvSpPr/>
          <p:nvPr/>
        </p:nvSpPr>
        <p:spPr>
          <a:xfrm>
            <a:off x="123120" y="4302000"/>
            <a:ext cx="9032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phosphinate/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phosph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2"/>
          <p:cNvSpPr/>
          <p:nvPr/>
        </p:nvSpPr>
        <p:spPr>
          <a:xfrm>
            <a:off x="2211840" y="1969920"/>
            <a:ext cx="552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ethy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3"/>
          <p:cNvSpPr/>
          <p:nvPr/>
        </p:nvSpPr>
        <p:spPr>
          <a:xfrm>
            <a:off x="2211840" y="3121200"/>
            <a:ext cx="42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lysy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Oval 16"/>
          <p:cNvSpPr/>
          <p:nvPr/>
        </p:nvSpPr>
        <p:spPr>
          <a:xfrm>
            <a:off x="2278080" y="455760"/>
            <a:ext cx="336600" cy="35244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Oval 17"/>
          <p:cNvSpPr/>
          <p:nvPr/>
        </p:nvSpPr>
        <p:spPr>
          <a:xfrm>
            <a:off x="2065320" y="19080"/>
            <a:ext cx="336600" cy="35244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Oval 18"/>
          <p:cNvSpPr/>
          <p:nvPr/>
        </p:nvSpPr>
        <p:spPr>
          <a:xfrm>
            <a:off x="1539720" y="709560"/>
            <a:ext cx="336600" cy="35244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Oval 19"/>
          <p:cNvSpPr/>
          <p:nvPr/>
        </p:nvSpPr>
        <p:spPr>
          <a:xfrm>
            <a:off x="1387440" y="20520"/>
            <a:ext cx="336600" cy="35244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Oval 20"/>
          <p:cNvSpPr/>
          <p:nvPr/>
        </p:nvSpPr>
        <p:spPr>
          <a:xfrm>
            <a:off x="909720" y="266760"/>
            <a:ext cx="336600" cy="35244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Oval 21"/>
          <p:cNvSpPr/>
          <p:nvPr/>
        </p:nvSpPr>
        <p:spPr>
          <a:xfrm>
            <a:off x="1089000" y="1909800"/>
            <a:ext cx="336600" cy="35244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Oval 22"/>
          <p:cNvSpPr/>
          <p:nvPr/>
        </p:nvSpPr>
        <p:spPr>
          <a:xfrm>
            <a:off x="1414440" y="2859120"/>
            <a:ext cx="336600" cy="35244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Oval 23"/>
          <p:cNvSpPr/>
          <p:nvPr/>
        </p:nvSpPr>
        <p:spPr>
          <a:xfrm>
            <a:off x="1054080" y="2863800"/>
            <a:ext cx="336600" cy="35244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Oval 24"/>
          <p:cNvSpPr/>
          <p:nvPr/>
        </p:nvSpPr>
        <p:spPr>
          <a:xfrm>
            <a:off x="1217520" y="4064040"/>
            <a:ext cx="336600" cy="35244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Oval 25"/>
          <p:cNvSpPr/>
          <p:nvPr/>
        </p:nvSpPr>
        <p:spPr>
          <a:xfrm>
            <a:off x="1241280" y="4595760"/>
            <a:ext cx="336600" cy="35244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Oval 26"/>
          <p:cNvSpPr/>
          <p:nvPr/>
        </p:nvSpPr>
        <p:spPr>
          <a:xfrm>
            <a:off x="2930400" y="3030480"/>
            <a:ext cx="336600" cy="35244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Oval 27"/>
          <p:cNvSpPr/>
          <p:nvPr/>
        </p:nvSpPr>
        <p:spPr>
          <a:xfrm>
            <a:off x="2982960" y="1898640"/>
            <a:ext cx="336600" cy="352440"/>
          </a:xfrm>
          <a:prstGeom prst="ellipse">
            <a:avLst/>
          </a:prstGeom>
          <a:noFill/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10T06:01:01Z</dcterms:created>
  <dc:creator> </dc:creator>
  <dc:description/>
  <dc:language>en-US</dc:language>
  <cp:lastModifiedBy>Jonathan</cp:lastModifiedBy>
  <dcterms:modified xsi:type="dcterms:W3CDTF">2009-12-22T08:41:11Z</dcterms:modified>
  <cp:revision>6</cp:revision>
  <dc:subject/>
  <dc:title>Slide 1</dc:title>
</cp:coreProperties>
</file>